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6" r:id="rId2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6" userDrawn="1">
          <p15:clr>
            <a:srgbClr val="A4A3A4"/>
          </p15:clr>
        </p15:guide>
        <p15:guide id="2" pos="158" userDrawn="1">
          <p15:clr>
            <a:srgbClr val="A4A3A4"/>
          </p15:clr>
        </p15:guide>
        <p15:guide id="3" orient="horz" pos="3974" userDrawn="1">
          <p15:clr>
            <a:srgbClr val="A4A3A4"/>
          </p15:clr>
        </p15:guide>
        <p15:guide id="8" pos="5602" userDrawn="1">
          <p15:clr>
            <a:srgbClr val="A4A3A4"/>
          </p15:clr>
        </p15:guide>
        <p15:guide id="9" pos="2699" userDrawn="1">
          <p15:clr>
            <a:srgbClr val="A4A3A4"/>
          </p15:clr>
        </p15:guide>
        <p15:guide id="10" pos="519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97" autoAdjust="0"/>
    <p:restoredTop sz="92652" autoAdjust="0"/>
  </p:normalViewPr>
  <p:slideViewPr>
    <p:cSldViewPr snapToGrid="0" showGuides="1">
      <p:cViewPr varScale="1">
        <p:scale>
          <a:sx n="58" d="100"/>
          <a:sy n="58" d="100"/>
        </p:scale>
        <p:origin x="984" y="282"/>
      </p:cViewPr>
      <p:guideLst>
        <p:guide orient="horz" pos="346"/>
        <p:guide pos="158"/>
        <p:guide orient="horz" pos="3974"/>
        <p:guide pos="5602"/>
        <p:guide pos="2699"/>
        <p:guide pos="519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瑞貴 久野" userId="cfc45a03820de899" providerId="LiveId" clId="{6431B9FB-8F42-4758-A687-D722AB889154}"/>
    <pc:docChg chg="delSld">
      <pc:chgData name="瑞貴 久野" userId="cfc45a03820de899" providerId="LiveId" clId="{6431B9FB-8F42-4758-A687-D722AB889154}" dt="2025-12-03T11:59:08.894" v="3" actId="47"/>
      <pc:docMkLst>
        <pc:docMk/>
      </pc:docMkLst>
      <pc:sldChg chg="del">
        <pc:chgData name="瑞貴 久野" userId="cfc45a03820de899" providerId="LiveId" clId="{6431B9FB-8F42-4758-A687-D722AB889154}" dt="2025-12-03T11:59:08.894" v="3" actId="47"/>
        <pc:sldMkLst>
          <pc:docMk/>
          <pc:sldMk cId="3642152188" sldId="275"/>
        </pc:sldMkLst>
      </pc:sldChg>
      <pc:sldChg chg="del">
        <pc:chgData name="瑞貴 久野" userId="cfc45a03820de899" providerId="LiveId" clId="{6431B9FB-8F42-4758-A687-D722AB889154}" dt="2025-12-03T11:59:08.314" v="2" actId="47"/>
        <pc:sldMkLst>
          <pc:docMk/>
          <pc:sldMk cId="243260980" sldId="277"/>
        </pc:sldMkLst>
      </pc:sldChg>
      <pc:sldChg chg="del">
        <pc:chgData name="瑞貴 久野" userId="cfc45a03820de899" providerId="LiveId" clId="{6431B9FB-8F42-4758-A687-D722AB889154}" dt="2025-12-03T11:59:06.975" v="0" actId="47"/>
        <pc:sldMkLst>
          <pc:docMk/>
          <pc:sldMk cId="3245696708" sldId="278"/>
        </pc:sldMkLst>
      </pc:sldChg>
      <pc:sldChg chg="del">
        <pc:chgData name="瑞貴 久野" userId="cfc45a03820de899" providerId="LiveId" clId="{6431B9FB-8F42-4758-A687-D722AB889154}" dt="2025-12-03T11:59:07.664" v="1" actId="47"/>
        <pc:sldMkLst>
          <pc:docMk/>
          <pc:sldMk cId="2557645125" sldId="27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BADC6A84-B46E-49FA-AD5B-21FCDB6E3018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90625" y="1252538"/>
            <a:ext cx="4506913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06" tIns="48303" rIns="96606" bIns="4830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8"/>
          </a:xfrm>
          <a:prstGeom prst="rect">
            <a:avLst/>
          </a:prstGeom>
        </p:spPr>
        <p:txBody>
          <a:bodyPr vert="horz" lIns="96606" tIns="48303" rIns="96606" bIns="48303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B2D2A62E-0375-4C2B-A19B-15F74851C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7361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189038" y="1252538"/>
            <a:ext cx="4510087" cy="33813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 Table S3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D2A62E-0375-4C2B-A19B-15F74851CA5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18128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7817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7624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428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9839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487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999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744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4917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517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799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128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35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6FFF8B32-CA1A-949D-E40B-D96FF069F996}"/>
              </a:ext>
            </a:extLst>
          </p:cNvPr>
          <p:cNvSpPr/>
          <p:nvPr/>
        </p:nvSpPr>
        <p:spPr>
          <a:xfrm>
            <a:off x="103957" y="48531"/>
            <a:ext cx="8582090" cy="7352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2800" dirty="0">
                <a:solidFill>
                  <a:schemeClr val="tx1"/>
                </a:solidFill>
              </a:rPr>
              <a:t>Supplemental Table5: Characteristic of the participants in</a:t>
            </a:r>
          </a:p>
          <a:p>
            <a:r>
              <a:rPr kumimoji="1" lang="en-US" altLang="ja-JP" sz="2800" dirty="0">
                <a:solidFill>
                  <a:schemeClr val="tx1"/>
                </a:solidFill>
              </a:rPr>
              <a:t>                                       smoking and</a:t>
            </a:r>
            <a:r>
              <a:rPr kumimoji="1" lang="ja-JP" altLang="en-US" sz="2800" dirty="0">
                <a:solidFill>
                  <a:schemeClr val="tx1"/>
                </a:solidFill>
              </a:rPr>
              <a:t> </a:t>
            </a:r>
            <a:r>
              <a:rPr kumimoji="1" lang="en-US" altLang="ja-JP" sz="2800" dirty="0">
                <a:solidFill>
                  <a:schemeClr val="tx1"/>
                </a:solidFill>
              </a:rPr>
              <a:t>not smoking</a:t>
            </a:r>
            <a:r>
              <a:rPr kumimoji="1" lang="ja-JP" altLang="en-US" sz="2800" dirty="0">
                <a:solidFill>
                  <a:schemeClr val="tx1"/>
                </a:solidFill>
              </a:rPr>
              <a:t> </a:t>
            </a:r>
            <a:r>
              <a:rPr kumimoji="1" lang="en-US" altLang="ja-JP" sz="2800" dirty="0">
                <a:solidFill>
                  <a:schemeClr val="tx1"/>
                </a:solidFill>
              </a:rPr>
              <a:t>group </a:t>
            </a:r>
            <a:endParaRPr kumimoji="1" lang="ja-JP" altLang="en-US" sz="2800" dirty="0">
              <a:solidFill>
                <a:schemeClr val="tx1"/>
              </a:solidFill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BA99C043-C089-7FA5-734E-23AC1EE325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0232710"/>
              </p:ext>
            </p:extLst>
          </p:nvPr>
        </p:nvGraphicFramePr>
        <p:xfrm>
          <a:off x="369453" y="958524"/>
          <a:ext cx="8405093" cy="5756033"/>
        </p:xfrm>
        <a:graphic>
          <a:graphicData uri="http://schemas.openxmlformats.org/drawingml/2006/table">
            <a:tbl>
              <a:tblPr/>
              <a:tblGrid>
                <a:gridCol w="3468699">
                  <a:extLst>
                    <a:ext uri="{9D8B030D-6E8A-4147-A177-3AD203B41FA5}">
                      <a16:colId xmlns:a16="http://schemas.microsoft.com/office/drawing/2014/main" val="131430130"/>
                    </a:ext>
                  </a:extLst>
                </a:gridCol>
                <a:gridCol w="791330">
                  <a:extLst>
                    <a:ext uri="{9D8B030D-6E8A-4147-A177-3AD203B41FA5}">
                      <a16:colId xmlns:a16="http://schemas.microsoft.com/office/drawing/2014/main" val="3504298338"/>
                    </a:ext>
                  </a:extLst>
                </a:gridCol>
                <a:gridCol w="1355928">
                  <a:extLst>
                    <a:ext uri="{9D8B030D-6E8A-4147-A177-3AD203B41FA5}">
                      <a16:colId xmlns:a16="http://schemas.microsoft.com/office/drawing/2014/main" val="3269429012"/>
                    </a:ext>
                  </a:extLst>
                </a:gridCol>
                <a:gridCol w="843064">
                  <a:extLst>
                    <a:ext uri="{9D8B030D-6E8A-4147-A177-3AD203B41FA5}">
                      <a16:colId xmlns:a16="http://schemas.microsoft.com/office/drawing/2014/main" val="293225431"/>
                    </a:ext>
                  </a:extLst>
                </a:gridCol>
                <a:gridCol w="1199888">
                  <a:extLst>
                    <a:ext uri="{9D8B030D-6E8A-4147-A177-3AD203B41FA5}">
                      <a16:colId xmlns:a16="http://schemas.microsoft.com/office/drawing/2014/main" val="1643776640"/>
                    </a:ext>
                  </a:extLst>
                </a:gridCol>
                <a:gridCol w="746184">
                  <a:extLst>
                    <a:ext uri="{9D8B030D-6E8A-4147-A177-3AD203B41FA5}">
                      <a16:colId xmlns:a16="http://schemas.microsoft.com/office/drawing/2014/main" val="2068121892"/>
                    </a:ext>
                  </a:extLst>
                </a:gridCol>
              </a:tblGrid>
              <a:tr h="36666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ja-JP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mok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on-Smok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</a:t>
                      </a:r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-value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5550101"/>
                  </a:ext>
                </a:extLst>
              </a:tr>
              <a:tr h="36666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n=121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n=553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88736691"/>
                  </a:ext>
                </a:extLst>
              </a:tr>
              <a:tr h="381947">
                <a:tc v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edia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Quartile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range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　　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dia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Quartile rang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77004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ge </a:t>
                      </a: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year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3.0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52.0 - 69.0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7.0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4.0 - 71.0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&lt;0.00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136013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 (mg/dl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8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0.68 - 0.88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0.61 - 0.79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&lt;0.00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932836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GFR (ml/min/1.73m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4.6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8.6 – 84.0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2.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7.0 – 79.0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243739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MI (kg/m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0.7 – 25.3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0.8 - 25.3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3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386896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stimated volume of salt intake (g/day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9.3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.3 – 11.2)</a:t>
                      </a:r>
                      <a:endParaRPr kumimoji="1" lang="ja-JP" altLang="en-US" sz="1400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.3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.9 – 10.9)</a:t>
                      </a:r>
                      <a:endParaRPr kumimoji="1" lang="ja-JP" altLang="en-US" sz="1400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4967357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IS (</a:t>
                      </a:r>
                      <a:r>
                        <a:rPr lang="el-GR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μ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ol/L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8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.5 – 5.2)</a:t>
                      </a:r>
                      <a:endParaRPr kumimoji="1" lang="ja-JP" altLang="en-US" sz="1400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.7 – 5.0)</a:t>
                      </a:r>
                      <a:endParaRPr kumimoji="1" lang="ja-JP" altLang="en-US" sz="1400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315601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Urinary albumin creatinine ratio (mg/</a:t>
                      </a: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Cr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) 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.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5.0 – 18.4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.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.4 – 19.7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4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8089698"/>
                  </a:ext>
                </a:extLst>
              </a:tr>
              <a:tr h="410640"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%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%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3655654"/>
                  </a:ext>
                </a:extLst>
              </a:tr>
              <a:tr h="410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le, sex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81.8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39.6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&lt;0.00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403749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revalence of hypertension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4.8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8.8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341013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revalence of diabetes mellitus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.4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9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508092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revalence of constipation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8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3.1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11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1.5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41965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743916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381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 algn="l">
          <a:defRPr kumimoji="1" dirty="0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11</TotalTime>
  <Words>245</Words>
  <Application>Microsoft Office PowerPoint</Application>
  <PresentationFormat>画面に合わせる (4:3)</PresentationFormat>
  <Paragraphs>8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貴弥 阿部</dc:creator>
  <cp:lastModifiedBy>瑞貴 久野</cp:lastModifiedBy>
  <cp:revision>8</cp:revision>
  <cp:lastPrinted>2024-02-04T05:40:39Z</cp:lastPrinted>
  <dcterms:created xsi:type="dcterms:W3CDTF">2024-01-17T10:41:08Z</dcterms:created>
  <dcterms:modified xsi:type="dcterms:W3CDTF">2025-12-03T11:59:11Z</dcterms:modified>
</cp:coreProperties>
</file>